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4266F6-46CF-422C-818C-936AF313DD5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2144D2-8050-4FD3-B37F-E6DD485689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A5AE84-616F-456B-B458-AAEA412331E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DC4C1A-ACED-46F1-9384-4FB3908E3AD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7EFB44-2374-4451-A309-102DA026949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C973DE-A56F-477C-96B3-46C3D581BB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164F77-A078-4EEC-8317-15736F8834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551921-4674-4BCD-A4F0-B02AF09445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09D92C-EA82-4AFA-819B-2587EF29B1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848081-B040-4610-BD2B-8B8F5BD416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675909-728A-4BC0-A745-520DE2ACC0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DB6351-D868-4DEF-91E2-5AE65268EE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_tradn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_tradn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B76D2C-816D-4E9E-B550-27AE1A6E252E}" type="slidenum">
              <a:rPr b="0" lang="es-ES_tradnl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3 Rectángulo"/>
          <p:cNvSpPr/>
          <p:nvPr/>
        </p:nvSpPr>
        <p:spPr>
          <a:xfrm>
            <a:off x="863640" y="4821120"/>
            <a:ext cx="7416720" cy="146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NA methylation profile of the CpG island promoter for the NUDT16 and DCP2  genes analyzed by the 450K DNA methylation microarray. Single CpG absolute methylation levels (0 – 1) are shown. Blue, methylated; yellow, unmethylated. Data from 10 T-cell lymphocytes and 10 Peripheral Blood Mononuclear Cell (PBMC) samples are shown in addition to normal colon (n=10) and lung (n=10) obtained from the TCGA database. The DNA sequences are unmethylated in all case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2" descr=""/>
          <p:cNvPicPr/>
          <p:nvPr/>
        </p:nvPicPr>
        <p:blipFill>
          <a:blip r:embed="rId1"/>
          <a:stretch/>
        </p:blipFill>
        <p:spPr>
          <a:xfrm>
            <a:off x="399960" y="1413000"/>
            <a:ext cx="8344080" cy="2879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7-27T09:43:04Z</dcterms:created>
  <dc:creator>smoran</dc:creator>
  <dc:description/>
  <dc:language>en-US</dc:language>
  <cp:lastModifiedBy>vidya.p</cp:lastModifiedBy>
  <dcterms:modified xsi:type="dcterms:W3CDTF">2017-04-10T10:33:35Z</dcterms:modified>
  <cp:revision>6</cp:revision>
  <dc:subject/>
  <dc:title>Diapositiva 1</dc:title>
</cp:coreProperties>
</file>